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12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/>
          <p:nvPr/>
        </p:nvGrpSpPr>
        <p:grpSpPr>
          <a:xfrm>
            <a:off x="899593" y="980728"/>
            <a:ext cx="3508527" cy="5231158"/>
            <a:chOff x="1371601" y="76200"/>
            <a:chExt cx="3427981" cy="4721568"/>
          </a:xfrm>
        </p:grpSpPr>
        <p:sp>
          <p:nvSpPr>
            <p:cNvPr id="6" name="TextBox 5"/>
            <p:cNvSpPr txBox="1"/>
            <p:nvPr/>
          </p:nvSpPr>
          <p:spPr>
            <a:xfrm>
              <a:off x="3528080" y="4520769"/>
              <a:ext cx="12715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ametocytes/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702250" y="193875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371601" y="76200"/>
              <a:ext cx="447558" cy="3416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1462" y="880718"/>
            <a:ext cx="4419600" cy="12192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921" y="2318384"/>
            <a:ext cx="4265141" cy="1720412"/>
          </a:xfrm>
          <a:prstGeom prst="rect">
            <a:avLst/>
          </a:prstGeom>
        </p:spPr>
      </p:pic>
      <p:sp>
        <p:nvSpPr>
          <p:cNvPr id="11" name="Rectangle 1"/>
          <p:cNvSpPr/>
          <p:nvPr/>
        </p:nvSpPr>
        <p:spPr>
          <a:xfrm>
            <a:off x="271555" y="111174"/>
            <a:ext cx="1409111" cy="276999"/>
          </a:xfrm>
          <a:prstGeom prst="rect">
            <a:avLst/>
          </a:prstGeom>
          <a:ln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>
            <a:spAutoFit/>
          </a:bodyPr>
          <a:lstStyle/>
          <a:p>
            <a:pPr lvl="0"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5938605" y="1490318"/>
            <a:ext cx="24160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OD ≈ 0.02 gametocytes/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5938605" y="2890929"/>
            <a:ext cx="241604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OD ≈ 3 copies/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800" y="4285604"/>
            <a:ext cx="4227262" cy="1556187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1188389" y="47559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5950734" y="4981676"/>
            <a:ext cx="25584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OD ≈ 0.004 gametocytes/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058810" y="3985685"/>
            <a:ext cx="843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pies/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3549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6</Words>
  <Application>Microsoft Office PowerPoint</Application>
  <PresentationFormat>全屏显示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YH-pc</dc:creator>
  <cp:lastModifiedBy>ZYH-pc</cp:lastModifiedBy>
  <cp:revision>2</cp:revision>
  <dcterms:created xsi:type="dcterms:W3CDTF">2017-01-11T03:35:46Z</dcterms:created>
  <dcterms:modified xsi:type="dcterms:W3CDTF">2017-01-12T09:34:43Z</dcterms:modified>
</cp:coreProperties>
</file>